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7" d="100"/>
          <a:sy n="67" d="100"/>
        </p:scale>
        <p:origin x="-1854" y="-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26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922" b="21216"/>
          <a:stretch/>
        </p:blipFill>
        <p:spPr>
          <a:xfrm>
            <a:off x="1231524" y="4191000"/>
            <a:ext cx="1975391" cy="1524000"/>
          </a:xfrm>
          <a:prstGeom prst="rect">
            <a:avLst/>
          </a:prstGeom>
          <a:noFill/>
        </p:spPr>
      </p:pic>
      <p:sp>
        <p:nvSpPr>
          <p:cNvPr id="10" name="Rectangle 9"/>
          <p:cNvSpPr/>
          <p:nvPr/>
        </p:nvSpPr>
        <p:spPr>
          <a:xfrm>
            <a:off x="5638800" y="41910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4191000"/>
            <a:ext cx="1981200" cy="1524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IE" sz="2400" dirty="0"/>
              <a:t>SPECT/CT imaging of inflammation and calcification in human carotid atherosclerosis to identify the plaque at risk of rupture </a:t>
            </a:r>
            <a:endParaRPr lang="en-US" altLang="en-US" sz="24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599"/>
            <a:ext cx="6400800" cy="1365105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 algn="just"/>
            <a:r>
              <a:rPr lang="en-IE" sz="800" b="1" dirty="0"/>
              <a:t>K. Van der Heiden, </a:t>
            </a:r>
            <a:r>
              <a:rPr lang="en-IE" sz="800" b="1" dirty="0" err="1"/>
              <a:t>PhD,</a:t>
            </a:r>
            <a:r>
              <a:rPr lang="en-IE" sz="800" b="1" baseline="30000" dirty="0" err="1"/>
              <a:t>#a</a:t>
            </a:r>
            <a:r>
              <a:rPr lang="en-IE" sz="800" b="1" dirty="0"/>
              <a:t> H.E. Barrett, PhD,</a:t>
            </a:r>
            <a:r>
              <a:rPr lang="en-IE" sz="800" b="1" baseline="30000" dirty="0"/>
              <a:t>#</a:t>
            </a:r>
            <a:r>
              <a:rPr lang="en-IE" sz="800" b="1" baseline="30000" dirty="0" err="1"/>
              <a:t>a,b</a:t>
            </a:r>
            <a:r>
              <a:rPr lang="en-IE" sz="800" b="1" dirty="0"/>
              <a:t> E.J. Meester, </a:t>
            </a:r>
            <a:r>
              <a:rPr lang="en-IE" sz="800" b="1" dirty="0" err="1"/>
              <a:t>PhD</a:t>
            </a:r>
            <a:r>
              <a:rPr lang="en-IE" sz="800" b="1" baseline="30000" dirty="0" err="1"/>
              <a:t>a,b</a:t>
            </a:r>
            <a:r>
              <a:rPr lang="en-IE" sz="800" b="1" dirty="0"/>
              <a:t>  K. van Gaalen, </a:t>
            </a:r>
            <a:r>
              <a:rPr lang="en-IE" sz="800" b="1" dirty="0" err="1"/>
              <a:t>BAppSc</a:t>
            </a:r>
            <a:r>
              <a:rPr lang="en-IE" sz="800" b="1" dirty="0"/>
              <a:t>,</a:t>
            </a:r>
            <a:r>
              <a:rPr lang="en-IE" sz="800" b="1" baseline="30000" dirty="0"/>
              <a:t> a</a:t>
            </a:r>
            <a:r>
              <a:rPr lang="en-IE" sz="800" b="1" dirty="0"/>
              <a:t> B.J. Krenning, MD, </a:t>
            </a:r>
            <a:r>
              <a:rPr lang="en-IE" sz="800" b="1" dirty="0" err="1"/>
              <a:t>PhD,</a:t>
            </a:r>
            <a:r>
              <a:rPr lang="en-IE" sz="800" b="1" baseline="30000" dirty="0" err="1"/>
              <a:t>c</a:t>
            </a:r>
            <a:r>
              <a:rPr lang="en-IE" sz="800" b="1" dirty="0"/>
              <a:t> F.J. Beekman, </a:t>
            </a:r>
            <a:r>
              <a:rPr lang="en-IE" sz="800" b="1" dirty="0" err="1"/>
              <a:t>PhD,</a:t>
            </a:r>
            <a:r>
              <a:rPr lang="en-IE" sz="800" b="1" baseline="30000" dirty="0" err="1"/>
              <a:t>d,e,f</a:t>
            </a:r>
            <a:r>
              <a:rPr lang="en-IE" sz="800" b="1" dirty="0"/>
              <a:t>, E. de Blois, PhD,</a:t>
            </a:r>
            <a:r>
              <a:rPr lang="en-IE" sz="800" b="1" baseline="30000" dirty="0"/>
              <a:t> b</a:t>
            </a:r>
            <a:r>
              <a:rPr lang="en-IE" sz="800" b="1" dirty="0"/>
              <a:t> J. de Swart, </a:t>
            </a:r>
            <a:r>
              <a:rPr lang="en-IE" sz="800" b="1" dirty="0" err="1"/>
              <a:t>BAppSc,</a:t>
            </a:r>
            <a:r>
              <a:rPr lang="en-IE" sz="800" b="1" baseline="30000" dirty="0" err="1"/>
              <a:t>b</a:t>
            </a:r>
            <a:r>
              <a:rPr lang="en-IE" sz="800" b="1" dirty="0"/>
              <a:t> H.J.M. </a:t>
            </a:r>
            <a:r>
              <a:rPr lang="en-IE" sz="800" b="1" dirty="0" err="1"/>
              <a:t>Verhagen</a:t>
            </a:r>
            <a:r>
              <a:rPr lang="en-IE" sz="800" b="1" dirty="0"/>
              <a:t>, MD, </a:t>
            </a:r>
            <a:r>
              <a:rPr lang="en-IE" sz="800" b="1" dirty="0" err="1"/>
              <a:t>PhD,</a:t>
            </a:r>
            <a:r>
              <a:rPr lang="en-IE" sz="800" b="1" baseline="30000" dirty="0" err="1"/>
              <a:t>g</a:t>
            </a:r>
            <a:r>
              <a:rPr lang="en-IE" sz="800" b="1" dirty="0"/>
              <a:t> A. van der Lugt, MD, </a:t>
            </a:r>
            <a:r>
              <a:rPr lang="en-IE" sz="800" b="1" dirty="0" err="1"/>
              <a:t>PhD,</a:t>
            </a:r>
            <a:r>
              <a:rPr lang="en-IE" sz="800" b="1" baseline="30000" dirty="0" err="1"/>
              <a:t>b</a:t>
            </a:r>
            <a:r>
              <a:rPr lang="en-IE" sz="800" b="1" dirty="0"/>
              <a:t> J.P. </a:t>
            </a:r>
            <a:r>
              <a:rPr lang="en-IE" sz="800" b="1" dirty="0" err="1"/>
              <a:t>Norenberg</a:t>
            </a:r>
            <a:r>
              <a:rPr lang="en-IE" sz="800" b="1" smtClean="0"/>
              <a:t>, PhD, </a:t>
            </a:r>
            <a:r>
              <a:rPr lang="en-IE" sz="800" b="1" dirty="0" err="1"/>
              <a:t>PharmD,</a:t>
            </a:r>
            <a:r>
              <a:rPr lang="en-IE" sz="800" b="1" baseline="30000" dirty="0" err="1"/>
              <a:t>h</a:t>
            </a:r>
            <a:r>
              <a:rPr lang="en-IE" sz="800" b="1" dirty="0"/>
              <a:t> M. de Jong, </a:t>
            </a:r>
            <a:r>
              <a:rPr lang="en-IE" sz="800" b="1" dirty="0" err="1"/>
              <a:t>PhD,</a:t>
            </a:r>
            <a:r>
              <a:rPr lang="en-IE" sz="800" b="1" baseline="30000" dirty="0" err="1"/>
              <a:t>b</a:t>
            </a:r>
            <a:r>
              <a:rPr lang="en-IE" sz="800" b="1" dirty="0"/>
              <a:t> M.R. Bernsen, </a:t>
            </a:r>
            <a:r>
              <a:rPr lang="en-IE" sz="800" b="1" dirty="0" err="1"/>
              <a:t>PhD,</a:t>
            </a:r>
            <a:r>
              <a:rPr lang="en-IE" sz="800" b="1" baseline="30000" dirty="0" err="1"/>
              <a:t>b,i</a:t>
            </a:r>
            <a:r>
              <a:rPr lang="en-IE" sz="800" b="1" dirty="0"/>
              <a:t> and F.J.H. Gijsen, </a:t>
            </a:r>
            <a:r>
              <a:rPr lang="en-IE" sz="800" b="1" dirty="0" err="1"/>
              <a:t>PhD,</a:t>
            </a:r>
            <a:r>
              <a:rPr lang="en-IE" sz="800" b="1" baseline="30000" dirty="0" err="1"/>
              <a:t>a</a:t>
            </a:r>
            <a:endParaRPr lang="en-US" sz="800" dirty="0"/>
          </a:p>
          <a:p>
            <a:pPr algn="just"/>
            <a:r>
              <a:rPr lang="en-IE" sz="800" baseline="30000" dirty="0" err="1"/>
              <a:t>a</a:t>
            </a:r>
            <a:r>
              <a:rPr lang="en-IE" sz="800" dirty="0" err="1"/>
              <a:t>Biomedical</a:t>
            </a:r>
            <a:r>
              <a:rPr lang="en-IE" sz="800" dirty="0"/>
              <a:t> Engineering, Department of Cardiology, Erasmus MC, Rotterdam, Netherlands, </a:t>
            </a:r>
            <a:r>
              <a:rPr lang="en-IE" sz="800" baseline="30000" dirty="0" err="1"/>
              <a:t>b</a:t>
            </a:r>
            <a:r>
              <a:rPr lang="en-IE" sz="800" dirty="0" err="1"/>
              <a:t>Department</a:t>
            </a:r>
            <a:r>
              <a:rPr lang="en-IE" sz="800" dirty="0"/>
              <a:t> of Radiology &amp; Nuclear Medicine, Erasmus MC, Rotterdam, Netherlands, </a:t>
            </a:r>
            <a:r>
              <a:rPr lang="en-IE" sz="800" baseline="30000" dirty="0" err="1"/>
              <a:t>c</a:t>
            </a:r>
            <a:r>
              <a:rPr lang="en-IE" sz="800" dirty="0" err="1"/>
              <a:t>Department</a:t>
            </a:r>
            <a:r>
              <a:rPr lang="en-IE" sz="800" dirty="0"/>
              <a:t> of Cardiology, Erasmus MC, Rotterdam, Netherlands, </a:t>
            </a:r>
            <a:r>
              <a:rPr lang="en-GB" sz="800" baseline="30000" dirty="0" err="1"/>
              <a:t>d</a:t>
            </a:r>
            <a:r>
              <a:rPr lang="en-GB" sz="800" dirty="0" err="1"/>
              <a:t>MiLabs</a:t>
            </a:r>
            <a:r>
              <a:rPr lang="en-GB" sz="800" dirty="0"/>
              <a:t>, B.V., Utrecht, Netherlands, </a:t>
            </a:r>
            <a:r>
              <a:rPr lang="en-IE" sz="800" baseline="30000" dirty="0" err="1"/>
              <a:t>e</a:t>
            </a:r>
            <a:r>
              <a:rPr lang="en-IE" sz="800" dirty="0" err="1"/>
              <a:t>Section</a:t>
            </a:r>
            <a:r>
              <a:rPr lang="en-IE" sz="800" dirty="0"/>
              <a:t> Biomedical Imaging, Department Radiation Science &amp; Technology, Delft University of Technology, The Netherlands, </a:t>
            </a:r>
            <a:r>
              <a:rPr lang="en-IE" sz="800" baseline="30000" dirty="0" err="1"/>
              <a:t>f</a:t>
            </a:r>
            <a:r>
              <a:rPr lang="en-IE" sz="800" dirty="0" err="1"/>
              <a:t>Department</a:t>
            </a:r>
            <a:r>
              <a:rPr lang="en-IE" sz="800" dirty="0"/>
              <a:t> of Translational Neuroscience, Brain Centre Rudolf Magnus, University Medical Centre Utrecht, The Netherlands, </a:t>
            </a:r>
            <a:r>
              <a:rPr lang="en-IE" sz="800" baseline="30000" dirty="0" err="1"/>
              <a:t>g</a:t>
            </a:r>
            <a:r>
              <a:rPr lang="en-IE" sz="800" dirty="0" err="1"/>
              <a:t>Department</a:t>
            </a:r>
            <a:r>
              <a:rPr lang="en-IE" sz="800" dirty="0"/>
              <a:t> of Vascular Surgery, Erasmus MC, Rotterdam, Netherlands, </a:t>
            </a:r>
            <a:r>
              <a:rPr lang="en-IE" sz="800" baseline="30000" dirty="0" err="1"/>
              <a:t>h</a:t>
            </a:r>
            <a:r>
              <a:rPr lang="en-IE" sz="800" dirty="0" err="1"/>
              <a:t>Radiopharmaceutical</a:t>
            </a:r>
            <a:r>
              <a:rPr lang="en-IE" sz="800" dirty="0"/>
              <a:t> Sciences, University of New Mexico, Albuquerque, NM, </a:t>
            </a:r>
            <a:r>
              <a:rPr lang="en-IE" sz="800" baseline="30000" dirty="0" err="1"/>
              <a:t>i</a:t>
            </a:r>
            <a:r>
              <a:rPr lang="en-IE" sz="800" dirty="0" err="1"/>
              <a:t>Applied</a:t>
            </a:r>
            <a:r>
              <a:rPr lang="en-IE" sz="800" dirty="0"/>
              <a:t> Molecular Imaging Erasmus Core Facility Erasmus MC Rotterdam, Netherlands </a:t>
            </a:r>
            <a:endParaRPr lang="en-US" sz="800" dirty="0"/>
          </a:p>
          <a:p>
            <a:pPr algn="just"/>
            <a:r>
              <a:rPr lang="en-IE" sz="800" dirty="0"/>
              <a:t>#contributed equally to this work</a:t>
            </a:r>
            <a:endParaRPr lang="en-US" sz="800" dirty="0"/>
          </a:p>
          <a:p>
            <a:pPr algn="just"/>
            <a:endParaRPr lang="en-US" altLang="en-US" sz="8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" descr="http://www.tenderguide.nl/opdrachtgever_files/ziekenhuizen/logo-erasmus-mc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1636" y="4584197"/>
            <a:ext cx="1875527" cy="7376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 </a:t>
            </a:r>
            <a:r>
              <a:rPr lang="en-IE" sz="2400" dirty="0"/>
              <a:t>Calcification and inflammation are atherosclerotic plaque compositional biomarkers that have both been linked to stroke risk. </a:t>
            </a: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2- </a:t>
            </a:r>
            <a:r>
              <a:rPr lang="en-IE" sz="2400" dirty="0"/>
              <a:t>SPECT and PET have the unique capability to target specific biological processes like inflammation, and are used in combination with multi-slice CT which can visualize the volume and pattern of calcification. </a:t>
            </a:r>
          </a:p>
          <a:p>
            <a:pPr marL="0" indent="0">
              <a:buNone/>
            </a:pPr>
            <a:r>
              <a:rPr lang="en-IE" altLang="en-US" sz="2400" dirty="0"/>
              <a:t>3-</a:t>
            </a:r>
            <a:r>
              <a:rPr lang="en-US" altLang="en-US" sz="2400" dirty="0"/>
              <a:t> </a:t>
            </a:r>
            <a:r>
              <a:rPr lang="en-IE" sz="2400" dirty="0"/>
              <a:t>The aim of this study was to evaluate the co-existing prevalence of calcification and inflammation in human carotid plaques with respect to plaque phenotype to determine the value of hybrid imaging of these biomarkers.</a:t>
            </a:r>
            <a:endParaRPr lang="en-US" sz="2400" dirty="0"/>
          </a:p>
          <a:p>
            <a:pPr marL="0" indent="0">
              <a:buNone/>
            </a:pP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</a:t>
            </a:r>
            <a:r>
              <a:rPr lang="en-US" altLang="en-US" sz="2800" dirty="0">
                <a:solidFill>
                  <a:srgbClr val="000000"/>
                </a:solidFill>
              </a:rPr>
              <a:t>Experimental, </a:t>
            </a:r>
            <a:r>
              <a:rPr lang="en-US" altLang="en-US" sz="2800" i="1" dirty="0">
                <a:solidFill>
                  <a:srgbClr val="000000"/>
                </a:solidFill>
              </a:rPr>
              <a:t>ex vivo </a:t>
            </a:r>
            <a:r>
              <a:rPr lang="en-US" altLang="en-US" sz="2800" dirty="0">
                <a:solidFill>
                  <a:srgbClr val="000000"/>
                </a:solidFill>
              </a:rPr>
              <a:t>study</a:t>
            </a:r>
            <a:r>
              <a:rPr lang="en-US" altLang="en-US" sz="2000" dirty="0"/>
              <a:t>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IE" sz="2800" dirty="0"/>
              <a:t>Human carotid plaques, obtained from endarterectomy.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Calcification volume fraction and pattern in human carotid plaque material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Degree of inflammation (radioligand</a:t>
            </a:r>
            <a:r>
              <a:rPr lang="en-US" altLang="en-US" sz="2400" i="1" dirty="0"/>
              <a:t> </a:t>
            </a:r>
            <a:r>
              <a:rPr lang="en-US" altLang="en-US" sz="2400" dirty="0"/>
              <a:t>uptake) in human carotid plaque material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laque phenotype classification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62000" y="5314384"/>
            <a:ext cx="7795532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Hybrid imaging of calcification and inflammation in human carotid plaque</a:t>
            </a:r>
          </a:p>
          <a:p>
            <a:r>
              <a:rPr lang="en-GB" sz="1100" dirty="0"/>
              <a:t>CT images (a, d) and corresponding SPECT images of uptake for [</a:t>
            </a:r>
            <a:r>
              <a:rPr lang="en-GB" sz="1100" baseline="30000" dirty="0"/>
              <a:t>111</a:t>
            </a:r>
            <a:r>
              <a:rPr lang="en-GB" sz="1100" dirty="0"/>
              <a:t>In]In-DANBIRT (b, e) </a:t>
            </a:r>
          </a:p>
          <a:p>
            <a:r>
              <a:rPr lang="en-GB" sz="1100" dirty="0"/>
              <a:t>with overlay image (c, f) of two typical examples (1 a-c, 2 d-f). </a:t>
            </a:r>
            <a:endParaRPr lang="en-US" sz="1100" dirty="0"/>
          </a:p>
          <a:p>
            <a:endParaRPr lang="en-US" sz="11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F75207FE-E995-4F29-88DD-47A15A6EC14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1199" y="1548202"/>
            <a:ext cx="4842569" cy="3766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Afbeelding 12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39" t="91264" r="18497" b="2916"/>
          <a:stretch/>
        </p:blipFill>
        <p:spPr>
          <a:xfrm>
            <a:off x="2909358" y="3882706"/>
            <a:ext cx="3172884" cy="29969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747077" y="4488359"/>
            <a:ext cx="8001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100" b="1" dirty="0"/>
              <a:t>Analysis of calcification pattern and inflammation level with distinct plaque phenotype</a:t>
            </a:r>
          </a:p>
          <a:p>
            <a:r>
              <a:rPr lang="en-IE" sz="1100" dirty="0"/>
              <a:t>Calcification</a:t>
            </a:r>
            <a:r>
              <a:rPr lang="en-IE" sz="1100" b="1" dirty="0"/>
              <a:t> </a:t>
            </a:r>
            <a:r>
              <a:rPr lang="en-IE" sz="1100" dirty="0"/>
              <a:t>pattern with the accompanying degree of [</a:t>
            </a:r>
            <a:r>
              <a:rPr lang="en-IE" sz="1100" baseline="30000" dirty="0"/>
              <a:t>111</a:t>
            </a:r>
            <a:r>
              <a:rPr lang="en-IE" sz="1100" dirty="0"/>
              <a:t>In]In-DANBIRT uptake and plaque phenotypes for each 2-mm segment analysed (PIT, pathological intimal thickening; FCALC, </a:t>
            </a:r>
            <a:r>
              <a:rPr lang="en-IE" sz="1100" dirty="0" err="1"/>
              <a:t>fibrocalcific</a:t>
            </a:r>
            <a:r>
              <a:rPr lang="en-IE" sz="1100" dirty="0"/>
              <a:t>; FCA, fibrous cap atheroma).</a:t>
            </a:r>
            <a:endParaRPr lang="en-US" sz="1100" dirty="0"/>
          </a:p>
          <a:p>
            <a:endParaRPr lang="en-US" sz="1100" dirty="0"/>
          </a:p>
        </p:txBody>
      </p:sp>
      <p:pic>
        <p:nvPicPr>
          <p:cNvPr id="12" name="Afbeelding 12">
            <a:extLst>
              <a:ext uri="{FF2B5EF4-FFF2-40B4-BE49-F238E27FC236}">
                <a16:creationId xmlns:a16="http://schemas.microsoft.com/office/drawing/2014/main" xmlns="" id="{CE553555-D871-4379-B939-814405B60233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61" t="2884" r="32658" b="53118"/>
          <a:stretch/>
        </p:blipFill>
        <p:spPr>
          <a:xfrm>
            <a:off x="518626" y="1720542"/>
            <a:ext cx="3261677" cy="2172376"/>
          </a:xfrm>
          <a:prstGeom prst="rect">
            <a:avLst/>
          </a:prstGeom>
        </p:spPr>
      </p:pic>
      <p:pic>
        <p:nvPicPr>
          <p:cNvPr id="13" name="Afbeelding 12">
            <a:extLst>
              <a:ext uri="{FF2B5EF4-FFF2-40B4-BE49-F238E27FC236}">
                <a16:creationId xmlns:a16="http://schemas.microsoft.com/office/drawing/2014/main" xmlns="" id="{6FC2CC9B-EA8D-454A-A04C-1FC7753E30B9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61" t="49888" r="32658" b="9289"/>
          <a:stretch/>
        </p:blipFill>
        <p:spPr>
          <a:xfrm>
            <a:off x="5486400" y="1766561"/>
            <a:ext cx="3261677" cy="2015649"/>
          </a:xfrm>
          <a:prstGeom prst="rect">
            <a:avLst/>
          </a:prstGeom>
        </p:spPr>
      </p:pic>
      <p:pic>
        <p:nvPicPr>
          <p:cNvPr id="14" name="Afbeelding 12">
            <a:extLst>
              <a:ext uri="{FF2B5EF4-FFF2-40B4-BE49-F238E27FC236}">
                <a16:creationId xmlns:a16="http://schemas.microsoft.com/office/drawing/2014/main" xmlns="" id="{0F370E41-29D6-446A-A8FA-F0800D25BF7D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499" t="2884" b="53118"/>
          <a:stretch/>
        </p:blipFill>
        <p:spPr>
          <a:xfrm>
            <a:off x="3816870" y="1723459"/>
            <a:ext cx="1669530" cy="21723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 A</a:t>
            </a:r>
            <a:r>
              <a:rPr lang="en-IE" sz="2400" dirty="0"/>
              <a:t>n inverse relationship between calcification volume and inflammation was evident in highly calcified, </a:t>
            </a:r>
            <a:r>
              <a:rPr lang="en-IE" sz="2400" dirty="0" err="1"/>
              <a:t>fibrocalcific</a:t>
            </a:r>
            <a:r>
              <a:rPr lang="en-IE" sz="2400" dirty="0"/>
              <a:t>, stable plaque segments. </a:t>
            </a: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2- </a:t>
            </a:r>
            <a:r>
              <a:rPr lang="en-IE" altLang="en-US" sz="2400" dirty="0"/>
              <a:t>S</a:t>
            </a:r>
            <a:r>
              <a:rPr lang="en-IE" sz="2400" dirty="0"/>
              <a:t>egments with little or no calcification presented with a moderate to high degree of inflammation, often coinciding with the more dangerous fibrous cap atheroma phenotype.</a:t>
            </a: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3-</a:t>
            </a:r>
            <a:r>
              <a:rPr lang="en-IE" sz="2400" dirty="0"/>
              <a:t>Calcification imaging alone </a:t>
            </a:r>
            <a:r>
              <a:rPr lang="en-IE" sz="2400"/>
              <a:t>can accurately </a:t>
            </a:r>
            <a:r>
              <a:rPr lang="en-IE" sz="2400" dirty="0"/>
              <a:t>identify highly calcified, stable, fibrocalcific plaques. </a:t>
            </a: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4- </a:t>
            </a:r>
            <a:r>
              <a:rPr lang="en-IE" sz="2400" dirty="0"/>
              <a:t>To identify high-risk plaques, with little or no calcification, hybrid imaging of calcification and inflammation could provide diagnostic benefit. </a:t>
            </a:r>
            <a:endParaRPr lang="en-US" sz="2400" dirty="0"/>
          </a:p>
          <a:p>
            <a:pPr marL="0" indent="0">
              <a:buNone/>
            </a:pP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Words>683</Words>
  <Application>Microsoft Office PowerPoint</Application>
  <PresentationFormat>On-screen Show (4:3)</PresentationFormat>
  <Paragraphs>39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SPECT/CT imaging of inflammation and calcification in human carotid atherosclerosis to identify the plaque at risk of rupture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Santhiya M.</cp:lastModifiedBy>
  <cp:revision>107</cp:revision>
  <dcterms:created xsi:type="dcterms:W3CDTF">2011-04-18T21:44:13Z</dcterms:created>
  <dcterms:modified xsi:type="dcterms:W3CDTF">2021-07-26T08:52:20Z</dcterms:modified>
</cp:coreProperties>
</file>